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1F1C40-594F-473F-A848-EB5EB85F1D7A}" v="11" dt="2022-09-15T05:49:47.6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881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120" y="13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2555CF-DC6F-5423-7F75-E3A4844D51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08B8CD2-F0A4-10DC-6B74-DDC4834B94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A777FA-FCD3-B7A5-9D38-7BC897506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1D83AE4-D08C-DECA-1A89-296ADC69C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7C0677-078D-4FCA-4884-BB0BD69C8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346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8780DA-4C32-0884-F8A4-8E716EAA6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5EB0FDB-3EF3-0C12-4722-E041EB684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A7CAE33-A77C-C6D8-B730-B21B7B045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6747B21-632F-AF69-3187-D91513843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46DEE93-2239-3BD8-002D-883185441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9962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E217E4C-EED0-2943-C890-74959303F0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356382F-77A3-6824-0474-3A6E34A464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EB80BED-F248-9573-B9D8-D4D35B8F8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0D56D-473A-E8CE-021E-F207CBBC0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94F7342-E49D-9417-7C2D-AD5C31F91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61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2142D4-F5B9-FA2E-C7F5-4B73D433C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AB3C325-F715-782A-F21B-689BF55B7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7D00699-787C-2BE5-A354-9D36EBB90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C247A82-0F7A-0D8C-274E-CDC125956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5C11F8A-2687-EDAC-49B5-002938C53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7111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DD99EF-2BB3-BA25-616B-7F1BAE541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50C4671-2C2E-6665-FA29-2872D7876E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FBBA4C5-EEF1-20F6-5320-1C19B5191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490E48-81F0-8DB0-935B-2927BD400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35A261C-248B-68FD-70C9-6398C344C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318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3848AA-5135-F12C-90E1-24A4854C2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7F3090A-5800-9C20-5AE3-FEF1B2DFA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003CEAB-2744-1504-1542-51195CA724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286097A-5792-4588-9D10-29390FD02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45113BA-4D85-1CB8-FCDC-0487F8CD7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F779B3-241D-C8FF-F601-41C982916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5021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2A08D0-30D7-9736-963D-305B5332D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54959A5-92FA-0294-1CBE-E9588AC14C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1EB57E6-B0E1-9361-FB05-72AC4A4908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547E0C99-FBBE-0D39-93C2-B5BADB7C67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4A9E7EB-70B6-FCB1-2BC5-3C8FB08754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3A5DD06-2449-8875-3F18-06A8196EA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4545EFC-DE42-8778-CAF8-BBE2131AA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C397A84-CF1E-D51A-D01B-5ED85E2A0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685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72CB51-D92B-3E84-1F0F-3A6174F1A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339238A-C6D7-77C6-81BD-095C0FBB6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568916B-29E5-6BCE-0814-7C7B22778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99B240E-840E-7BE7-4D8F-C27AB14BE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28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0BBE02F-4050-54DE-58DC-AD87ABDB9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E3660C4-8C76-3B86-B3B3-642C342BE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DA76F8E-E36E-F611-06BF-C854191E8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64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8E7107-B5D7-FCC9-2DB8-4E271AB3F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EEC8623-278D-A43C-6210-451136B714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F649A39-47C1-02A8-CB14-372ACFF48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219D26C-FFDD-D140-4B78-1210BD965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74DAA3C-B2CF-1051-7EA8-A7A7A4ACA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C0FC3AF-D08B-908B-13A0-5AFDFFE83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075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154FCD5-39CD-5C1B-A900-05DAA8573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9CC5B44-3B46-64B6-1027-7CF6767AA0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71B25D-1E5C-2706-32B8-2E33A99E4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340746-492F-A98B-837E-8C5A645E7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2494E25-1EFA-C2D6-E45F-07F55DD6B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390A7-459B-A087-D1F2-8CA54BC4F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3402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35686A0-9E5A-873C-B13F-110DDF807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706AFC2-048B-30A8-7CF8-EA3BA83B9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157270-A9BA-BEC2-1CC2-7B3226BD36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C8303-2C78-46CD-942E-35A8FE79346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051C9C-BD6E-9B46-22ED-7DF35F64FB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71A535-6FFF-B9B9-4DAE-2D0C6A545B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EAD44-7E70-4B24-9CB8-423D9ED298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606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CED4753B-0F02-CD12-2D1A-F4BECCCB5D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0365896"/>
              </p:ext>
            </p:extLst>
          </p:nvPr>
        </p:nvGraphicFramePr>
        <p:xfrm>
          <a:off x="838200" y="1594904"/>
          <a:ext cx="10515600" cy="3415780"/>
        </p:xfrm>
        <a:graphic>
          <a:graphicData uri="http://schemas.openxmlformats.org/drawingml/2006/table">
            <a:tbl>
              <a:tblPr/>
              <a:tblGrid>
                <a:gridCol w="1165080">
                  <a:extLst>
                    <a:ext uri="{9D8B030D-6E8A-4147-A177-3AD203B41FA5}">
                      <a16:colId xmlns:a16="http://schemas.microsoft.com/office/drawing/2014/main" val="1309848759"/>
                    </a:ext>
                  </a:extLst>
                </a:gridCol>
                <a:gridCol w="1165080">
                  <a:extLst>
                    <a:ext uri="{9D8B030D-6E8A-4147-A177-3AD203B41FA5}">
                      <a16:colId xmlns:a16="http://schemas.microsoft.com/office/drawing/2014/main" val="2323111276"/>
                    </a:ext>
                  </a:extLst>
                </a:gridCol>
                <a:gridCol w="1165080">
                  <a:extLst>
                    <a:ext uri="{9D8B030D-6E8A-4147-A177-3AD203B41FA5}">
                      <a16:colId xmlns:a16="http://schemas.microsoft.com/office/drawing/2014/main" val="536668990"/>
                    </a:ext>
                  </a:extLst>
                </a:gridCol>
                <a:gridCol w="1165080">
                  <a:extLst>
                    <a:ext uri="{9D8B030D-6E8A-4147-A177-3AD203B41FA5}">
                      <a16:colId xmlns:a16="http://schemas.microsoft.com/office/drawing/2014/main" val="3398202772"/>
                    </a:ext>
                  </a:extLst>
                </a:gridCol>
                <a:gridCol w="1171056">
                  <a:extLst>
                    <a:ext uri="{9D8B030D-6E8A-4147-A177-3AD203B41FA5}">
                      <a16:colId xmlns:a16="http://schemas.microsoft.com/office/drawing/2014/main" val="978259412"/>
                    </a:ext>
                  </a:extLst>
                </a:gridCol>
                <a:gridCol w="1171056">
                  <a:extLst>
                    <a:ext uri="{9D8B030D-6E8A-4147-A177-3AD203B41FA5}">
                      <a16:colId xmlns:a16="http://schemas.microsoft.com/office/drawing/2014/main" val="2212470379"/>
                    </a:ext>
                  </a:extLst>
                </a:gridCol>
                <a:gridCol w="1171056">
                  <a:extLst>
                    <a:ext uri="{9D8B030D-6E8A-4147-A177-3AD203B41FA5}">
                      <a16:colId xmlns:a16="http://schemas.microsoft.com/office/drawing/2014/main" val="358768493"/>
                    </a:ext>
                  </a:extLst>
                </a:gridCol>
                <a:gridCol w="1171056">
                  <a:extLst>
                    <a:ext uri="{9D8B030D-6E8A-4147-A177-3AD203B41FA5}">
                      <a16:colId xmlns:a16="http://schemas.microsoft.com/office/drawing/2014/main" val="1613145528"/>
                    </a:ext>
                  </a:extLst>
                </a:gridCol>
                <a:gridCol w="1171056">
                  <a:extLst>
                    <a:ext uri="{9D8B030D-6E8A-4147-A177-3AD203B41FA5}">
                      <a16:colId xmlns:a16="http://schemas.microsoft.com/office/drawing/2014/main" val="346904877"/>
                    </a:ext>
                  </a:extLst>
                </a:gridCol>
              </a:tblGrid>
              <a:tr h="205662">
                <a:tc gridSpan="4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696225"/>
                  </a:ext>
                </a:extLst>
              </a:tr>
              <a:tr h="205662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4326518"/>
                  </a:ext>
                </a:extLst>
              </a:tr>
              <a:tr h="21460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Non-trimmed sequences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6595179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. bassian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JEF-41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Non-infected red mite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JEF-410-i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nfected red mite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5947258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eplicate</a:t>
                      </a:r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3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3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7129032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Total sequences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36,616,478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6,171,238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7,648,092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8,269,132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7,347,996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6,332,684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2,462,39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8,294,405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8218553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Sequence length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0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167285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% GC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8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5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5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9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9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9266819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847064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6265934"/>
                  </a:ext>
                </a:extLst>
              </a:tr>
              <a:tr h="21460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Trimmed sequences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2497921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　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B. bassian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JEF-41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Non-infected red mite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JEF-410-infected red mite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6529065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Replicate</a:t>
                      </a:r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3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1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2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#3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0218198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Total sequences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36,506,684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6,058,483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7,507,233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8,138,828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7,272,530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6,190,289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2,387,488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18,180,882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941323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Sequence length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T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75-101 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8213418"/>
                  </a:ext>
                </a:extLst>
              </a:tr>
              <a:tr h="2146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% GC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8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5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50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9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9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" panose="02020603050405020304" pitchFamily="18" charset="0"/>
                          <a:ea typeface="맑은 고딕" panose="020B0503020000020004" pitchFamily="34" charset="-127"/>
                        </a:rPr>
                        <a:t>47</a:t>
                      </a:r>
                    </a:p>
                  </a:txBody>
                  <a:tcPr marL="8942" marR="8942" marT="894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110551"/>
                  </a:ext>
                </a:extLst>
              </a:tr>
            </a:tbl>
          </a:graphicData>
        </a:graphic>
      </p:graphicFrame>
      <p:grpSp>
        <p:nvGrpSpPr>
          <p:cNvPr id="6" name="그룹 5">
            <a:extLst>
              <a:ext uri="{FF2B5EF4-FFF2-40B4-BE49-F238E27FC236}">
                <a16:creationId xmlns:a16="http://schemas.microsoft.com/office/drawing/2014/main" id="{FEAB454F-A540-A1B4-A632-03F44AE73BD4}"/>
              </a:ext>
            </a:extLst>
          </p:cNvPr>
          <p:cNvGrpSpPr/>
          <p:nvPr/>
        </p:nvGrpSpPr>
        <p:grpSpPr>
          <a:xfrm>
            <a:off x="4637645" y="1936396"/>
            <a:ext cx="3527150" cy="3415780"/>
            <a:chOff x="4637645" y="1182848"/>
            <a:chExt cx="3527150" cy="5033394"/>
          </a:xfrm>
          <a:solidFill>
            <a:schemeClr val="bg1"/>
          </a:solidFill>
        </p:grpSpPr>
        <p:sp>
          <p:nvSpPr>
            <p:cNvPr id="2" name="직사각형 1">
              <a:extLst>
                <a:ext uri="{FF2B5EF4-FFF2-40B4-BE49-F238E27FC236}">
                  <a16:creationId xmlns:a16="http://schemas.microsoft.com/office/drawing/2014/main" id="{63A22F73-FDB6-B426-55D8-1E4B0B04AE43}"/>
                </a:ext>
              </a:extLst>
            </p:cNvPr>
            <p:cNvSpPr/>
            <p:nvPr/>
          </p:nvSpPr>
          <p:spPr>
            <a:xfrm>
              <a:off x="4637645" y="1182848"/>
              <a:ext cx="45719" cy="5033394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2BA704CF-2B7D-331D-0BCB-6EB058AA0B8D}"/>
                </a:ext>
              </a:extLst>
            </p:cNvPr>
            <p:cNvSpPr/>
            <p:nvPr/>
          </p:nvSpPr>
          <p:spPr>
            <a:xfrm>
              <a:off x="8119076" y="1182848"/>
              <a:ext cx="45719" cy="5033394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6188277D-BC0D-336E-10F0-8A941370C551}"/>
              </a:ext>
            </a:extLst>
          </p:cNvPr>
          <p:cNvSpPr txBox="1"/>
          <p:nvPr/>
        </p:nvSpPr>
        <p:spPr>
          <a:xfrm>
            <a:off x="733697" y="1419435"/>
            <a:ext cx="6096000" cy="455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2 Table. Summary of Illumina sequences.</a:t>
            </a:r>
            <a:endParaRPr lang="ko-KR" altLang="ko-KR" sz="14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438257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166</Words>
  <Application>Microsoft Office PowerPoint</Application>
  <PresentationFormat>와이드스크린</PresentationFormat>
  <Paragraphs>9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Times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소은</dc:creator>
  <cp:lastModifiedBy>김재수</cp:lastModifiedBy>
  <cp:revision>4</cp:revision>
  <dcterms:created xsi:type="dcterms:W3CDTF">2022-09-13T05:05:03Z</dcterms:created>
  <dcterms:modified xsi:type="dcterms:W3CDTF">2023-01-06T05:09:01Z</dcterms:modified>
</cp:coreProperties>
</file>